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9004D-7DAB-4A79-B121-094F6A36E5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B32E7-FAD5-44B6-8487-DB59FE34B6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39018-C8D2-4F4B-A191-50C03273C7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F4CB2-2005-43C0-A9A2-21F6D5BD44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CA956-D06A-4475-A607-0A11B3C902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EB9AB-B4F7-4C3A-B26E-AC6BB2B05A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BBC7B-7B74-4FAA-9E95-C219757209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356CF-9A36-4345-8406-E684DDD2E4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B58E5-A3B3-4052-BB32-8862143859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40788-36A9-4158-9F16-5ED8484A56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6260C-3217-456D-999B-AA6BFB53D9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B8741-0EA2-4123-8FF7-09C70F0056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3FD91F-DB88-4FDC-9F2D-446AB12559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0" y="1152360"/>
            <a:ext cx="396720" cy="355680"/>
            <a:chOff x="0" y="1152360"/>
            <a:chExt cx="396720" cy="355680"/>
          </a:xfrm>
        </p:grpSpPr>
        <p:sp>
          <p:nvSpPr>
            <p:cNvPr id="42" name="AutoShape 7"/>
            <p:cNvSpPr/>
            <p:nvPr/>
          </p:nvSpPr>
          <p:spPr>
            <a:xfrm>
              <a:off x="0" y="1152360"/>
              <a:ext cx="396720" cy="35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" name="Rectangle 12"/>
          <p:cNvSpPr/>
          <p:nvPr/>
        </p:nvSpPr>
        <p:spPr>
          <a:xfrm>
            <a:off x="1141560" y="895320"/>
            <a:ext cx="7088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r" pos="228600"/>
                <a:tab algn="l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S2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ange of WG score in the present study (A) and in TCGA cohort (B). (online only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l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3"/>
          <p:cNvSpPr/>
          <p:nvPr/>
        </p:nvSpPr>
        <p:spPr>
          <a:xfrm>
            <a:off x="1800" y="-191880"/>
            <a:ext cx="1807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r" pos="228600"/>
                <a:tab algn="l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100"/>
            </a:b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r" pos="228600"/>
                <a:tab algn="l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4"/>
          <p:cNvSpPr/>
          <p:nvPr/>
        </p:nvSpPr>
        <p:spPr>
          <a:xfrm>
            <a:off x="1800" y="510480"/>
            <a:ext cx="180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6"/>
          <p:cNvSpPr/>
          <p:nvPr/>
        </p:nvSpPr>
        <p:spPr>
          <a:xfrm>
            <a:off x="1800" y="7201440"/>
            <a:ext cx="18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r" pos="228600"/>
                <a:tab algn="l" pos="343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19"/>
          <p:cNvGrpSpPr/>
          <p:nvPr/>
        </p:nvGrpSpPr>
        <p:grpSpPr>
          <a:xfrm>
            <a:off x="0" y="1447920"/>
            <a:ext cx="9144000" cy="3863880"/>
            <a:chOff x="0" y="1447920"/>
            <a:chExt cx="9144000" cy="3863880"/>
          </a:xfrm>
        </p:grpSpPr>
        <p:sp>
          <p:nvSpPr>
            <p:cNvPr id="48" name="TextBox 7"/>
            <p:cNvSpPr/>
            <p:nvPr/>
          </p:nvSpPr>
          <p:spPr>
            <a:xfrm>
              <a:off x="2897280" y="14479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8"/>
            <p:cNvSpPr/>
            <p:nvPr/>
          </p:nvSpPr>
          <p:spPr>
            <a:xfrm>
              <a:off x="6172200" y="1447920"/>
              <a:ext cx="336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18"/>
            <p:cNvGrpSpPr/>
            <p:nvPr/>
          </p:nvGrpSpPr>
          <p:grpSpPr>
            <a:xfrm>
              <a:off x="0" y="1828800"/>
              <a:ext cx="9144000" cy="3483000"/>
              <a:chOff x="0" y="1828800"/>
              <a:chExt cx="9144000" cy="3483000"/>
            </a:xfrm>
          </p:grpSpPr>
          <p:pic>
            <p:nvPicPr>
              <p:cNvPr id="51" name="Picture 5" descr=""/>
              <p:cNvPicPr/>
              <p:nvPr/>
            </p:nvPicPr>
            <p:blipFill>
              <a:blip r:embed="rId1"/>
              <a:srcRect l="0" t="0" r="23213" b="7281"/>
              <a:stretch/>
            </p:blipFill>
            <p:spPr>
              <a:xfrm>
                <a:off x="1523880" y="1920960"/>
                <a:ext cx="2924280" cy="2819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Picture 4" descr=""/>
              <p:cNvPicPr/>
              <p:nvPr/>
            </p:nvPicPr>
            <p:blipFill>
              <a:blip r:embed="rId2"/>
              <a:srcRect l="0" t="0" r="21078" b="5640"/>
              <a:stretch/>
            </p:blipFill>
            <p:spPr>
              <a:xfrm>
                <a:off x="4572000" y="1920960"/>
                <a:ext cx="3105000" cy="2828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 Box 9"/>
              <p:cNvSpPr/>
              <p:nvPr/>
            </p:nvSpPr>
            <p:spPr>
              <a:xfrm>
                <a:off x="6019920" y="4892760"/>
                <a:ext cx="914400" cy="3430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Calibri"/>
                  </a:rPr>
                  <a:t>WG sco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5"/>
              <p:cNvSpPr/>
              <p:nvPr/>
            </p:nvSpPr>
            <p:spPr>
              <a:xfrm>
                <a:off x="0" y="1828800"/>
                <a:ext cx="914400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46440" bIns="-46440" anchor="ctr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7"/>
              <p:cNvSpPr/>
              <p:nvPr/>
            </p:nvSpPr>
            <p:spPr>
              <a:xfrm>
                <a:off x="2666880" y="4969080"/>
                <a:ext cx="914400" cy="3427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Calibri"/>
                  </a:rPr>
                  <a:t>WG sco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Dr. K. Somasumdaram</dc:creator>
  <dc:description/>
  <dc:language>en-US</dc:language>
  <cp:lastModifiedBy>Drkumarvel</cp:lastModifiedBy>
  <dcterms:modified xsi:type="dcterms:W3CDTF">2013-04-05T04:53:25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